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624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252A29-8FF8-45DF-B0D8-F5323871F8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F362B93-C090-4A19-BFB8-692CB8880C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190949-C0F6-48EA-86D3-9B8098AA7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3715-6E52-4A9B-8A4B-EF28ECB98737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698008-431E-4804-910F-DC90163DD4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139F14-9819-4759-B7FB-34A9AFB6D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A6E0-15FF-4380-86F4-CE31342268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771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83DBC0-A143-4ADE-AEAA-004E5754BE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E6C592-760D-4A84-86B7-F91A51AAFD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6BC3B2-4293-40AA-A24A-F5DC9F3576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3715-6E52-4A9B-8A4B-EF28ECB98737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747E1F-3D45-43F2-8EC7-32880BE19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3CEACB-7AB7-45F6-B9F4-F9AC4449E2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A6E0-15FF-4380-86F4-CE31342268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7344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B7F934-0DEE-4A3F-BAC5-B8D2459BF7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34EC3A-B3A4-4F88-8743-FAB3A438CE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9C7A73-50C0-4662-87FC-8D6B3C5F11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3715-6E52-4A9B-8A4B-EF28ECB98737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6C419D-5659-4520-B97F-CB6CF1DA7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C724B7-7819-4EBA-8518-BBC621E122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A6E0-15FF-4380-86F4-CE31342268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47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688E02-FAB9-4B5D-A63D-234D3F0851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90D3CE-E66C-40CB-A1E1-81DAE46CD8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30247C-3FBD-4816-A4DA-44E0286959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3715-6E52-4A9B-8A4B-EF28ECB98737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3C5312-A9DB-45B5-B232-670DB7135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B0377E-732C-4AF1-B2AF-44474CAE6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A6E0-15FF-4380-86F4-CE31342268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409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02DC1E-0E66-4DC2-B3BA-EBD694D8C3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D8A32D-2413-4E95-B0D7-FB684B374E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2C82BF-9299-4A9A-8D9C-CB69D4DEB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3715-6E52-4A9B-8A4B-EF28ECB98737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51C4BF-B157-41C8-B581-9738F2217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973A76-6C58-4FB1-9C3B-ACB8C317D1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A6E0-15FF-4380-86F4-CE31342268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093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E1A70F-4620-4864-B54D-9E3CA77706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53914C-2308-4F6D-9C48-B0D4C60998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A1CD4D-C4F1-469D-BD49-83C2965D25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D99AFD-8059-4885-A2EC-75B5DD2277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3715-6E52-4A9B-8A4B-EF28ECB98737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30D333-9ED6-4488-BB93-60CFF6117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87E599-76E8-463D-B019-0CCA2687C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A6E0-15FF-4380-86F4-CE31342268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5962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170B01-D435-4F9E-A194-E18BFD7EAF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2421FD-3C9C-41B9-8E34-5BC4682B47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9D8528-8DC9-4533-B9C2-100B83E50C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678852-990C-40A3-9254-6D9A439083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1F5760D-F9ED-4F16-9217-8346226D4D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642C0BF-BB45-426E-AE0B-5DFC507F1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3715-6E52-4A9B-8A4B-EF28ECB98737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021DC22-BB3E-46CA-A1F4-965F58AC2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B9D6B0-C0F8-4C35-A85A-593E8FF82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A6E0-15FF-4380-86F4-CE31342268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701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A965A2-B546-4D61-A7BE-B572908D29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01BD3DD-1BCD-4FBF-8A70-78721AC505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3715-6E52-4A9B-8A4B-EF28ECB98737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4F1B8D9-1311-4CDB-9DF6-F8657B3556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C58681-E6FA-4C2C-A8DB-C4F486CC9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A6E0-15FF-4380-86F4-CE31342268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96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12F265-FC53-4B14-B711-43F9E7B10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3715-6E52-4A9B-8A4B-EF28ECB98737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37E7956-20F3-4B1C-B7E6-CDF92719E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7E56063-BD0E-472F-BB9A-EFA1267735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A6E0-15FF-4380-86F4-CE31342268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589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883CC2-FD40-430C-B7C2-B62F28742D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6D1E3A-0E21-4DAB-B47C-FB270B342E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A62E86-F0E6-426C-BB3F-51AE6CF1FD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2BA1D2-1FBE-46EC-B832-1963905FE5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3715-6E52-4A9B-8A4B-EF28ECB98737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A1B9E4-6E8A-417E-A75A-E50A63196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6F105D-8CDB-4E89-9EB4-D46AA83C6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A6E0-15FF-4380-86F4-CE31342268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6992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C26674-FD8C-4FE8-A51C-DD3EE01D40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05C7EB-EB8E-4ABA-8021-1D767D17E0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D2B8DD-BC96-4565-9BEA-160C034378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CA05B4-6098-4840-97E4-52DB967E5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3715-6E52-4A9B-8A4B-EF28ECB98737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93A6C4-4EC1-4670-8952-D52EDB75C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474DE7-4DCB-4D16-88F2-4BD7CA5C4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AA6E0-15FF-4380-86F4-CE31342268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800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E0FBFF-9920-4FED-9F0D-C9FD80CBBF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8A1177-13E6-464A-A75F-698027C2C2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064023-3408-4179-9849-A012D112B8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743715-6E52-4A9B-8A4B-EF28ECB98737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254C7B-C946-4E27-B690-741942284E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6539C0-4512-481F-ACE6-5A3851B155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AA6E0-15FF-4380-86F4-CE31342268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191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7746F8E7-BFD4-450F-A7CE-51F86CCA2C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3044" y="79792"/>
            <a:ext cx="6245912" cy="624591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6A46AF2-283A-432F-8866-4B87FD74C409}"/>
              </a:ext>
            </a:extLst>
          </p:cNvPr>
          <p:cNvSpPr txBox="1"/>
          <p:nvPr/>
        </p:nvSpPr>
        <p:spPr>
          <a:xfrm flipH="1">
            <a:off x="2853635" y="6374529"/>
            <a:ext cx="64847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 scatter plot of the first two principal components on genotypes of study subjects. </a:t>
            </a:r>
          </a:p>
        </p:txBody>
      </p:sp>
    </p:spTree>
    <p:extLst>
      <p:ext uri="{BB962C8B-B14F-4D97-AF65-F5344CB8AC3E}">
        <p14:creationId xmlns:p14="http://schemas.microsoft.com/office/powerpoint/2010/main" val="22077264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imeline&#10;&#10;Description automatically generated">
            <a:extLst>
              <a:ext uri="{FF2B5EF4-FFF2-40B4-BE49-F238E27FC236}">
                <a16:creationId xmlns:a16="http://schemas.microsoft.com/office/drawing/2014/main" id="{B0A456C8-7726-485A-97C1-BB74F08474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2725" y="355020"/>
            <a:ext cx="6686550" cy="534924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133B4C6-6AA7-4000-946B-853C9F35572F}"/>
              </a:ext>
            </a:extLst>
          </p:cNvPr>
          <p:cNvSpPr txBox="1"/>
          <p:nvPr/>
        </p:nvSpPr>
        <p:spPr>
          <a:xfrm flipH="1">
            <a:off x="2853635" y="5906285"/>
            <a:ext cx="64847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gion-based gene association test results for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uerto Ricans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exicans,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frican Americans. The top 5 genes were annotated. The green horizontal line indicates a Bonferroni-corrected threshold.</a:t>
            </a:r>
          </a:p>
        </p:txBody>
      </p:sp>
    </p:spTree>
    <p:extLst>
      <p:ext uri="{BB962C8B-B14F-4D97-AF65-F5344CB8AC3E}">
        <p14:creationId xmlns:p14="http://schemas.microsoft.com/office/powerpoint/2010/main" val="31991781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093C26E-AA5E-4B6F-B5B0-24F804029A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752725" y="355020"/>
            <a:ext cx="6686550" cy="534923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52A634B-04C7-44EC-80E0-D4BBEA5EBE66}"/>
              </a:ext>
            </a:extLst>
          </p:cNvPr>
          <p:cNvSpPr txBox="1"/>
          <p:nvPr/>
        </p:nvSpPr>
        <p:spPr>
          <a:xfrm flipH="1">
            <a:off x="2853635" y="5906285"/>
            <a:ext cx="64847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dicted QTL analysis of GWAS data using monocyte gene expression from the MESA cohort for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uerto Ricans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exicans,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frican Americans. The top 5 genes whose predicted expression level is associated with BDR were annotated. The green horizontal line indicates a Bonferroni-corrected threshold.</a:t>
            </a:r>
          </a:p>
        </p:txBody>
      </p:sp>
    </p:spTree>
    <p:extLst>
      <p:ext uri="{BB962C8B-B14F-4D97-AF65-F5344CB8AC3E}">
        <p14:creationId xmlns:p14="http://schemas.microsoft.com/office/powerpoint/2010/main" val="3105406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</TotalTime>
  <Words>109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o, Jaehyun</dc:creator>
  <cp:lastModifiedBy>Joo, Jaehyun</cp:lastModifiedBy>
  <cp:revision>6</cp:revision>
  <dcterms:created xsi:type="dcterms:W3CDTF">2021-07-27T01:07:04Z</dcterms:created>
  <dcterms:modified xsi:type="dcterms:W3CDTF">2021-08-24T04:29:25Z</dcterms:modified>
</cp:coreProperties>
</file>